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A9177-4B0D-4D4D-ACD0-DA2A1282DD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D6F9C-88DD-4B23-B886-8F69EDC0FC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2EDC71-147B-4BA5-871E-7B6C94918E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0FB357-48BC-4BEC-AEC2-A2908CB4A6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65C7FB-58F4-417B-AFEE-B340847463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94EE82-1AFD-4F3B-81BD-2F2CD96BD4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7CC65-CA2A-42C5-A5A7-4961BBF6D3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0208A8-9A3D-4CAA-A882-A50E9EFEE3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74E069-8CC8-441A-B450-EE28ED503D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70273D-B763-48FB-905C-87248D9AD9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46E5C-4BC6-4E6B-B6C5-511488C9AB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0420D-BC68-413E-9F90-B953FF029A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AD7DE58-4E84-427A-99ED-2424C24F53A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hyperlink" Target="http://www.microrna.org/" TargetMode="External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361800" y="763560"/>
            <a:ext cx="779760" cy="4175280"/>
          </a:xfrm>
          <a:prstGeom prst="rect">
            <a:avLst/>
          </a:prstGeom>
          <a:ln w="0">
            <a:noFill/>
          </a:ln>
        </p:spPr>
      </p:pic>
      <p:sp>
        <p:nvSpPr>
          <p:cNvPr id="42" name="TextBox 90"/>
          <p:cNvSpPr/>
          <p:nvPr/>
        </p:nvSpPr>
        <p:spPr>
          <a:xfrm>
            <a:off x="366840" y="50796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     8    24   (h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91"/>
          <p:cNvSpPr/>
          <p:nvPr/>
        </p:nvSpPr>
        <p:spPr>
          <a:xfrm>
            <a:off x="436680" y="279360"/>
            <a:ext cx="64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IR 6 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직선 연결선 117"/>
          <p:cNvSpPr/>
          <p:nvPr/>
        </p:nvSpPr>
        <p:spPr>
          <a:xfrm>
            <a:off x="371520" y="519120"/>
            <a:ext cx="776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직사각형 118"/>
          <p:cNvSpPr/>
          <p:nvPr/>
        </p:nvSpPr>
        <p:spPr>
          <a:xfrm>
            <a:off x="1081080" y="696960"/>
            <a:ext cx="1351080" cy="38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76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8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3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8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28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25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3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18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9b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61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770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0b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87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7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25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3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8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4a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00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62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50a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30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1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2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0e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38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0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41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2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32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3a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74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74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83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62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42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769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0a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62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1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31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5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40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276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35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06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3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71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그룹 1"/>
          <p:cNvGrpSpPr/>
          <p:nvPr/>
        </p:nvGrpSpPr>
        <p:grpSpPr>
          <a:xfrm>
            <a:off x="2001960" y="5584680"/>
            <a:ext cx="1866600" cy="336600"/>
            <a:chOff x="2001960" y="5584680"/>
            <a:chExt cx="1866600" cy="336600"/>
          </a:xfrm>
        </p:grpSpPr>
        <p:pic>
          <p:nvPicPr>
            <p:cNvPr id="47" name="Picture 5" descr=""/>
            <p:cNvPicPr/>
            <p:nvPr/>
          </p:nvPicPr>
          <p:blipFill>
            <a:blip r:embed="rId2"/>
            <a:stretch/>
          </p:blipFill>
          <p:spPr>
            <a:xfrm>
              <a:off x="2188080" y="5811120"/>
              <a:ext cx="808920" cy="110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TextBox 120"/>
            <p:cNvSpPr/>
            <p:nvPr/>
          </p:nvSpPr>
          <p:spPr>
            <a:xfrm>
              <a:off x="2001960" y="5584680"/>
              <a:ext cx="1866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-6.5                 5.5 (log2)  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49" name="Picture 3" descr=""/>
          <p:cNvPicPr/>
          <p:nvPr/>
        </p:nvPicPr>
        <p:blipFill>
          <a:blip r:embed="rId3"/>
          <a:stretch/>
        </p:blipFill>
        <p:spPr>
          <a:xfrm>
            <a:off x="1785960" y="770040"/>
            <a:ext cx="781200" cy="4176720"/>
          </a:xfrm>
          <a:prstGeom prst="rect">
            <a:avLst/>
          </a:prstGeom>
          <a:ln w="0">
            <a:noFill/>
          </a:ln>
        </p:spPr>
      </p:pic>
      <p:sp>
        <p:nvSpPr>
          <p:cNvPr id="50" name="직사각형 122"/>
          <p:cNvSpPr/>
          <p:nvPr/>
        </p:nvSpPr>
        <p:spPr>
          <a:xfrm>
            <a:off x="2541600" y="717480"/>
            <a:ext cx="863640" cy="39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3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62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06b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0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let-7a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615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00b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00c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4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1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b-1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3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01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638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50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let-7d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18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26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38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0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0d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3b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7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86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3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1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1d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07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68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72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7-1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40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1a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13a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25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74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24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01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7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19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74b_v16.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9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61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5a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0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3a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5a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39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23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5" descr=""/>
          <p:cNvPicPr/>
          <p:nvPr/>
        </p:nvPicPr>
        <p:blipFill>
          <a:blip r:embed="rId4"/>
          <a:stretch/>
        </p:blipFill>
        <p:spPr>
          <a:xfrm>
            <a:off x="3400560" y="752400"/>
            <a:ext cx="779400" cy="4356000"/>
          </a:xfrm>
          <a:prstGeom prst="rect">
            <a:avLst/>
          </a:prstGeom>
          <a:ln w="0">
            <a:noFill/>
          </a:ln>
        </p:spPr>
      </p:pic>
      <p:sp>
        <p:nvSpPr>
          <p:cNvPr id="52" name="직사각형 124"/>
          <p:cNvSpPr/>
          <p:nvPr/>
        </p:nvSpPr>
        <p:spPr>
          <a:xfrm>
            <a:off x="4129200" y="696960"/>
            <a:ext cx="1155600" cy="404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8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74a_v16.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3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1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50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46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20d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20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1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4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66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6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9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let-7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20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4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51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let-7d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308_v15.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90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24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20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6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14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31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74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7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40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65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5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9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1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let-7e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2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48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74_v14.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5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42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0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6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88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8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06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9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75_v15.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9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Picture 7" descr=""/>
          <p:cNvPicPr/>
          <p:nvPr/>
        </p:nvPicPr>
        <p:blipFill>
          <a:blip r:embed="rId5"/>
          <a:stretch/>
        </p:blipFill>
        <p:spPr>
          <a:xfrm>
            <a:off x="4976640" y="755640"/>
            <a:ext cx="787680" cy="4265640"/>
          </a:xfrm>
          <a:prstGeom prst="rect">
            <a:avLst/>
          </a:prstGeom>
          <a:ln w="0">
            <a:noFill/>
          </a:ln>
        </p:spPr>
      </p:pic>
      <p:sp>
        <p:nvSpPr>
          <p:cNvPr id="54" name="직사각형 126"/>
          <p:cNvSpPr/>
          <p:nvPr/>
        </p:nvSpPr>
        <p:spPr>
          <a:xfrm>
            <a:off x="5713560" y="698400"/>
            <a:ext cx="895320" cy="39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0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let-7i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6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7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0d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00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7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0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4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51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6-2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0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01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let-7g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30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77_v14.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let-7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6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7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29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00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8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7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03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let-7f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2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29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74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7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0e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13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78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4b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9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892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5b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48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0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5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0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3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6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629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98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8" descr=""/>
          <p:cNvPicPr/>
          <p:nvPr/>
        </p:nvPicPr>
        <p:blipFill>
          <a:blip r:embed="rId6"/>
          <a:stretch/>
        </p:blipFill>
        <p:spPr>
          <a:xfrm>
            <a:off x="371520" y="5533920"/>
            <a:ext cx="790560" cy="2159280"/>
          </a:xfrm>
          <a:prstGeom prst="rect">
            <a:avLst/>
          </a:prstGeom>
          <a:ln w="0">
            <a:noFill/>
          </a:ln>
        </p:spPr>
      </p:pic>
      <p:sp>
        <p:nvSpPr>
          <p:cNvPr id="56" name="직사각형 128"/>
          <p:cNvSpPr/>
          <p:nvPr/>
        </p:nvSpPr>
        <p:spPr>
          <a:xfrm>
            <a:off x="1123920" y="5478480"/>
            <a:ext cx="963720" cy="206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0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6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let-7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5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3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0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2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6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00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3a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6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0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94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30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21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0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79_v15.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487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35*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24-3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513c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96b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338-5p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맑은 고딕"/>
              </a:rPr>
              <a:t>hsa-miR-1826_v15.0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29"/>
          <p:cNvSpPr/>
          <p:nvPr/>
        </p:nvSpPr>
        <p:spPr>
          <a:xfrm>
            <a:off x="366840" y="528948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     8    24   (h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30"/>
          <p:cNvSpPr/>
          <p:nvPr/>
        </p:nvSpPr>
        <p:spPr>
          <a:xfrm>
            <a:off x="436680" y="5059440"/>
            <a:ext cx="64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IR 6 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직선 연결선 131"/>
          <p:cNvSpPr/>
          <p:nvPr/>
        </p:nvSpPr>
        <p:spPr>
          <a:xfrm>
            <a:off x="371520" y="5300640"/>
            <a:ext cx="776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32"/>
          <p:cNvSpPr/>
          <p:nvPr/>
        </p:nvSpPr>
        <p:spPr>
          <a:xfrm>
            <a:off x="1785960" y="52056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     8    24   (h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33"/>
          <p:cNvSpPr/>
          <p:nvPr/>
        </p:nvSpPr>
        <p:spPr>
          <a:xfrm>
            <a:off x="3411360" y="498600"/>
            <a:ext cx="1090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     8    24   (h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34"/>
          <p:cNvSpPr/>
          <p:nvPr/>
        </p:nvSpPr>
        <p:spPr>
          <a:xfrm>
            <a:off x="5013360" y="50976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     8    24   (h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35"/>
          <p:cNvSpPr/>
          <p:nvPr/>
        </p:nvSpPr>
        <p:spPr>
          <a:xfrm>
            <a:off x="1866960" y="270000"/>
            <a:ext cx="64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IR 6 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직선 연결선 136"/>
          <p:cNvSpPr/>
          <p:nvPr/>
        </p:nvSpPr>
        <p:spPr>
          <a:xfrm>
            <a:off x="1801800" y="511200"/>
            <a:ext cx="776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139"/>
          <p:cNvSpPr/>
          <p:nvPr/>
        </p:nvSpPr>
        <p:spPr>
          <a:xfrm>
            <a:off x="3476520" y="284040"/>
            <a:ext cx="64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IR 6 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직선 연결선 140"/>
          <p:cNvSpPr/>
          <p:nvPr/>
        </p:nvSpPr>
        <p:spPr>
          <a:xfrm>
            <a:off x="3411360" y="525600"/>
            <a:ext cx="776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141"/>
          <p:cNvSpPr/>
          <p:nvPr/>
        </p:nvSpPr>
        <p:spPr>
          <a:xfrm>
            <a:off x="5084640" y="295200"/>
            <a:ext cx="64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IR 6 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직선 연결선 142"/>
          <p:cNvSpPr/>
          <p:nvPr/>
        </p:nvSpPr>
        <p:spPr>
          <a:xfrm>
            <a:off x="5021280" y="534960"/>
            <a:ext cx="776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직사각형 2"/>
          <p:cNvSpPr/>
          <p:nvPr/>
        </p:nvSpPr>
        <p:spPr>
          <a:xfrm>
            <a:off x="436680" y="7937640"/>
            <a:ext cx="6271920" cy="64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Supplementary Figure S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 Extended datasets of 229 IR-responsive miRNAs in MCF7 cell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그룹 4"/>
          <p:cNvGrpSpPr/>
          <p:nvPr/>
        </p:nvGrpSpPr>
        <p:grpSpPr>
          <a:xfrm>
            <a:off x="531720" y="1571040"/>
            <a:ext cx="1920240" cy="1638000"/>
            <a:chOff x="531720" y="1571040"/>
            <a:chExt cx="1920240" cy="1638000"/>
          </a:xfrm>
        </p:grpSpPr>
        <p:pic>
          <p:nvPicPr>
            <p:cNvPr id="71" name="차트 78" descr=""/>
            <p:cNvPicPr/>
            <p:nvPr/>
          </p:nvPicPr>
          <p:blipFill>
            <a:blip r:embed="rId1"/>
            <a:stretch/>
          </p:blipFill>
          <p:spPr>
            <a:xfrm>
              <a:off x="870840" y="1669680"/>
              <a:ext cx="1335240" cy="1146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TextBox 79"/>
            <p:cNvSpPr/>
            <p:nvPr/>
          </p:nvSpPr>
          <p:spPr>
            <a:xfrm rot="16200000">
              <a:off x="85680" y="2016720"/>
              <a:ext cx="12902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miR-770-5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/ 5S r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3" name="그룹 3"/>
            <p:cNvGrpSpPr/>
            <p:nvPr/>
          </p:nvGrpSpPr>
          <p:grpSpPr>
            <a:xfrm>
              <a:off x="1412280" y="2665440"/>
              <a:ext cx="594720" cy="543600"/>
              <a:chOff x="1412280" y="2665440"/>
              <a:chExt cx="594720" cy="543600"/>
            </a:xfrm>
          </p:grpSpPr>
          <p:sp>
            <p:nvSpPr>
              <p:cNvPr id="74" name="TextBox 80"/>
              <p:cNvSpPr/>
              <p:nvPr/>
            </p:nvSpPr>
            <p:spPr>
              <a:xfrm rot="16200000">
                <a:off x="1339200" y="2889360"/>
                <a:ext cx="392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ppleGothic"/>
                  </a:rPr>
                  <a:t>Con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TextBox 146"/>
              <p:cNvSpPr/>
              <p:nvPr/>
            </p:nvSpPr>
            <p:spPr>
              <a:xfrm rot="16200000">
                <a:off x="1612080" y="2814120"/>
                <a:ext cx="54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ppleGothic"/>
                  </a:rPr>
                  <a:t>770-5p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6" name="TextBox 92"/>
            <p:cNvSpPr/>
            <p:nvPr/>
          </p:nvSpPr>
          <p:spPr>
            <a:xfrm>
              <a:off x="1582560" y="15984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7" name="Group 163"/>
            <p:cNvGrpSpPr/>
            <p:nvPr/>
          </p:nvGrpSpPr>
          <p:grpSpPr>
            <a:xfrm>
              <a:off x="1520640" y="1769040"/>
              <a:ext cx="375120" cy="73800"/>
              <a:chOff x="1520640" y="1769040"/>
              <a:chExt cx="375120" cy="73800"/>
            </a:xfrm>
          </p:grpSpPr>
          <p:sp>
            <p:nvSpPr>
              <p:cNvPr id="78" name="Straight Connector 163"/>
              <p:cNvSpPr/>
              <p:nvPr/>
            </p:nvSpPr>
            <p:spPr>
              <a:xfrm flipV="1">
                <a:off x="1893240" y="1769040"/>
                <a:ext cx="0" cy="73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Straight Connector 164"/>
              <p:cNvSpPr/>
              <p:nvPr/>
            </p:nvSpPr>
            <p:spPr>
              <a:xfrm flipV="1">
                <a:off x="1522440" y="1769040"/>
                <a:ext cx="0" cy="73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Straight Connector 162"/>
              <p:cNvSpPr/>
              <p:nvPr/>
            </p:nvSpPr>
            <p:spPr>
              <a:xfrm>
                <a:off x="1520640" y="1772280"/>
                <a:ext cx="375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1" name="TextBox 101"/>
            <p:cNvSpPr/>
            <p:nvPr/>
          </p:nvSpPr>
          <p:spPr>
            <a:xfrm>
              <a:off x="2010600" y="281412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ppleGothic"/>
                </a:rPr>
                <a:t>miR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2" name="그룹 5"/>
          <p:cNvGrpSpPr/>
          <p:nvPr/>
        </p:nvGrpSpPr>
        <p:grpSpPr>
          <a:xfrm>
            <a:off x="2398680" y="1585080"/>
            <a:ext cx="1817640" cy="1623600"/>
            <a:chOff x="2398680" y="1585080"/>
            <a:chExt cx="1817640" cy="1623600"/>
          </a:xfrm>
        </p:grpSpPr>
        <p:sp>
          <p:nvSpPr>
            <p:cNvPr id="83" name="TextBox 83"/>
            <p:cNvSpPr/>
            <p:nvPr/>
          </p:nvSpPr>
          <p:spPr>
            <a:xfrm rot="16200000">
              <a:off x="1942920" y="2040840"/>
              <a:ext cx="13100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BK m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/ Actin m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4" name="차트 86" descr=""/>
            <p:cNvPicPr/>
            <p:nvPr/>
          </p:nvPicPr>
          <p:blipFill>
            <a:blip r:embed="rId2"/>
            <a:stretch/>
          </p:blipFill>
          <p:spPr>
            <a:xfrm>
              <a:off x="2736720" y="1626840"/>
              <a:ext cx="1230840" cy="1177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TextBox 87"/>
            <p:cNvSpPr/>
            <p:nvPr/>
          </p:nvSpPr>
          <p:spPr>
            <a:xfrm>
              <a:off x="3295080" y="1598400"/>
              <a:ext cx="37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6" name="Group 163"/>
            <p:cNvGrpSpPr/>
            <p:nvPr/>
          </p:nvGrpSpPr>
          <p:grpSpPr>
            <a:xfrm>
              <a:off x="3290760" y="1769040"/>
              <a:ext cx="374760" cy="73800"/>
              <a:chOff x="3290760" y="1769040"/>
              <a:chExt cx="374760" cy="73800"/>
            </a:xfrm>
          </p:grpSpPr>
          <p:sp>
            <p:nvSpPr>
              <p:cNvPr id="87" name="Straight Connector 163"/>
              <p:cNvSpPr/>
              <p:nvPr/>
            </p:nvSpPr>
            <p:spPr>
              <a:xfrm flipV="1">
                <a:off x="3663000" y="1769040"/>
                <a:ext cx="0" cy="73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Straight Connector 164"/>
              <p:cNvSpPr/>
              <p:nvPr/>
            </p:nvSpPr>
            <p:spPr>
              <a:xfrm flipV="1">
                <a:off x="3292560" y="1769040"/>
                <a:ext cx="0" cy="73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Straight Connector 162"/>
              <p:cNvSpPr/>
              <p:nvPr/>
            </p:nvSpPr>
            <p:spPr>
              <a:xfrm>
                <a:off x="3290760" y="1772280"/>
                <a:ext cx="374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0" name="TextBox 99"/>
            <p:cNvSpPr/>
            <p:nvPr/>
          </p:nvSpPr>
          <p:spPr>
            <a:xfrm rot="16200000">
              <a:off x="3116160" y="2889360"/>
              <a:ext cx="39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ppleGothic"/>
                </a:rPr>
                <a:t>Co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146"/>
            <p:cNvSpPr/>
            <p:nvPr/>
          </p:nvSpPr>
          <p:spPr>
            <a:xfrm rot="16200000">
              <a:off x="3389400" y="2813760"/>
              <a:ext cx="54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ppleGothic"/>
                </a:rPr>
                <a:t>770-5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103"/>
            <p:cNvSpPr/>
            <p:nvPr/>
          </p:nvSpPr>
          <p:spPr>
            <a:xfrm>
              <a:off x="3774960" y="281412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ppleGothic"/>
                </a:rPr>
                <a:t>miR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3" name="그룹 6"/>
          <p:cNvGrpSpPr/>
          <p:nvPr/>
        </p:nvGrpSpPr>
        <p:grpSpPr>
          <a:xfrm>
            <a:off x="4166280" y="1486440"/>
            <a:ext cx="2272320" cy="1185480"/>
            <a:chOff x="4166280" y="1486440"/>
            <a:chExt cx="2272320" cy="1185480"/>
          </a:xfrm>
        </p:grpSpPr>
        <p:grpSp>
          <p:nvGrpSpPr>
            <p:cNvPr id="94" name="그룹 56"/>
            <p:cNvGrpSpPr/>
            <p:nvPr/>
          </p:nvGrpSpPr>
          <p:grpSpPr>
            <a:xfrm>
              <a:off x="4166280" y="1486440"/>
              <a:ext cx="2272320" cy="1185480"/>
              <a:chOff x="4166280" y="1486440"/>
              <a:chExt cx="2272320" cy="1185480"/>
            </a:xfrm>
          </p:grpSpPr>
          <p:pic>
            <p:nvPicPr>
              <p:cNvPr id="95" name="그림 57" descr=""/>
              <p:cNvPicPr/>
              <p:nvPr/>
            </p:nvPicPr>
            <p:blipFill>
              <a:blip r:embed="rId3"/>
              <a:stretch/>
            </p:blipFill>
            <p:spPr>
              <a:xfrm>
                <a:off x="4795560" y="2254680"/>
                <a:ext cx="538920" cy="1692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96" name="그림 58" descr=""/>
              <p:cNvPicPr/>
              <p:nvPr/>
            </p:nvPicPr>
            <p:blipFill>
              <a:blip r:embed="rId4"/>
              <a:stretch/>
            </p:blipFill>
            <p:spPr>
              <a:xfrm>
                <a:off x="4795560" y="2461320"/>
                <a:ext cx="539640" cy="1692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97" name="그림 59" descr=""/>
              <p:cNvPicPr/>
              <p:nvPr/>
            </p:nvPicPr>
            <p:blipFill>
              <a:blip r:embed="rId5">
                <a:lum contrast="26000"/>
              </a:blip>
              <a:stretch/>
            </p:blipFill>
            <p:spPr>
              <a:xfrm>
                <a:off x="4795560" y="2048040"/>
                <a:ext cx="538920" cy="1692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grpSp>
            <p:nvGrpSpPr>
              <p:cNvPr id="98" name="Group 19"/>
              <p:cNvGrpSpPr/>
              <p:nvPr/>
            </p:nvGrpSpPr>
            <p:grpSpPr>
              <a:xfrm>
                <a:off x="5334480" y="2220120"/>
                <a:ext cx="583920" cy="246240"/>
                <a:chOff x="5334480" y="2220120"/>
                <a:chExt cx="583920" cy="246240"/>
              </a:xfrm>
            </p:grpSpPr>
            <p:sp>
              <p:nvSpPr>
                <p:cNvPr id="99" name="TextBox 75"/>
                <p:cNvSpPr/>
                <p:nvPr/>
              </p:nvSpPr>
              <p:spPr>
                <a:xfrm>
                  <a:off x="5492160" y="2220120"/>
                  <a:ext cx="4262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AppleMyungjo"/>
                    </a:rPr>
                    <a:t>PBK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100" name="Straight Arrow Connector 170"/>
                <p:cNvCxnSpPr/>
                <p:nvPr/>
              </p:nvCxnSpPr>
              <p:spPr>
                <a:xfrm flipH="1" flipV="1">
                  <a:off x="5334480" y="2342160"/>
                  <a:ext cx="189360" cy="216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</p:grpSp>
          <p:grpSp>
            <p:nvGrpSpPr>
              <p:cNvPr id="101" name="Group 19"/>
              <p:cNvGrpSpPr/>
              <p:nvPr/>
            </p:nvGrpSpPr>
            <p:grpSpPr>
              <a:xfrm>
                <a:off x="5334120" y="2003040"/>
                <a:ext cx="1104480" cy="246240"/>
                <a:chOff x="5334120" y="2003040"/>
                <a:chExt cx="1104480" cy="246240"/>
              </a:xfrm>
            </p:grpSpPr>
            <p:sp>
              <p:nvSpPr>
                <p:cNvPr id="102" name="TextBox 73"/>
                <p:cNvSpPr/>
                <p:nvPr/>
              </p:nvSpPr>
              <p:spPr>
                <a:xfrm>
                  <a:off x="5494320" y="2003040"/>
                  <a:ext cx="944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AppleMyungjo"/>
                    </a:rPr>
                    <a:t>Cleaved PARP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103" name="Straight Arrow Connector 168"/>
                <p:cNvCxnSpPr/>
                <p:nvPr/>
              </p:nvCxnSpPr>
              <p:spPr>
                <a:xfrm flipH="1" flipV="1">
                  <a:off x="5334120" y="2125080"/>
                  <a:ext cx="189000" cy="216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</p:grpSp>
          <p:grpSp>
            <p:nvGrpSpPr>
              <p:cNvPr id="104" name="Group 19"/>
              <p:cNvGrpSpPr/>
              <p:nvPr/>
            </p:nvGrpSpPr>
            <p:grpSpPr>
              <a:xfrm>
                <a:off x="5334120" y="2425680"/>
                <a:ext cx="619920" cy="246240"/>
                <a:chOff x="5334120" y="2425680"/>
                <a:chExt cx="619920" cy="246240"/>
              </a:xfrm>
            </p:grpSpPr>
            <p:sp>
              <p:nvSpPr>
                <p:cNvPr id="105" name="TextBox 71"/>
                <p:cNvSpPr/>
                <p:nvPr/>
              </p:nvSpPr>
              <p:spPr>
                <a:xfrm>
                  <a:off x="5491440" y="2425680"/>
                  <a:ext cx="462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AppleMyungjo"/>
                    </a:rPr>
                    <a:t>Actin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106" name="Straight Arrow Connector 166"/>
                <p:cNvCxnSpPr/>
                <p:nvPr/>
              </p:nvCxnSpPr>
              <p:spPr>
                <a:xfrm flipH="1" flipV="1">
                  <a:off x="5334120" y="2547720"/>
                  <a:ext cx="189000" cy="216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</p:grpSp>
          <p:sp>
            <p:nvSpPr>
              <p:cNvPr id="107" name="직선 연결선 59"/>
              <p:cNvSpPr/>
              <p:nvPr/>
            </p:nvSpPr>
            <p:spPr>
              <a:xfrm>
                <a:off x="4709520" y="2135160"/>
                <a:ext cx="71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TextBox 64"/>
              <p:cNvSpPr/>
              <p:nvPr/>
            </p:nvSpPr>
            <p:spPr>
              <a:xfrm>
                <a:off x="4166280" y="2012040"/>
                <a:ext cx="612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ppleGothic"/>
                  </a:rPr>
                  <a:t>89 KDa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직선 연결선 59"/>
              <p:cNvSpPr/>
              <p:nvPr/>
            </p:nvSpPr>
            <p:spPr>
              <a:xfrm>
                <a:off x="4709520" y="2332800"/>
                <a:ext cx="71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TextBox 66"/>
              <p:cNvSpPr/>
              <p:nvPr/>
            </p:nvSpPr>
            <p:spPr>
              <a:xfrm>
                <a:off x="4166280" y="2209680"/>
                <a:ext cx="612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ppleGothic"/>
                  </a:rPr>
                  <a:t>40 KDa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직선 연결선 59"/>
              <p:cNvSpPr/>
              <p:nvPr/>
            </p:nvSpPr>
            <p:spPr>
              <a:xfrm>
                <a:off x="4709520" y="2541240"/>
                <a:ext cx="71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TextBox 68"/>
              <p:cNvSpPr/>
              <p:nvPr/>
            </p:nvSpPr>
            <p:spPr>
              <a:xfrm>
                <a:off x="4166280" y="2418120"/>
                <a:ext cx="612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ppleGothic"/>
                  </a:rPr>
                  <a:t>43 KDa 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TextBox 69"/>
              <p:cNvSpPr/>
              <p:nvPr/>
            </p:nvSpPr>
            <p:spPr>
              <a:xfrm rot="16200000">
                <a:off x="4736520" y="1710360"/>
                <a:ext cx="392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ppleGothic"/>
                  </a:rPr>
                  <a:t>Con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TextBox 146"/>
              <p:cNvSpPr/>
              <p:nvPr/>
            </p:nvSpPr>
            <p:spPr>
              <a:xfrm rot="16200000">
                <a:off x="4923720" y="1635120"/>
                <a:ext cx="54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ppleGothic"/>
                  </a:rPr>
                  <a:t>770-5p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15" name="TextBox 104"/>
            <p:cNvSpPr/>
            <p:nvPr/>
          </p:nvSpPr>
          <p:spPr>
            <a:xfrm>
              <a:off x="5328360" y="168588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ppleGothic"/>
                </a:rPr>
                <a:t>miR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6" name="TextBox 105"/>
          <p:cNvSpPr/>
          <p:nvPr/>
        </p:nvSpPr>
        <p:spPr>
          <a:xfrm>
            <a:off x="1382400" y="1170000"/>
            <a:ext cx="64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CT1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106"/>
          <p:cNvSpPr/>
          <p:nvPr/>
        </p:nvSpPr>
        <p:spPr>
          <a:xfrm>
            <a:off x="3161160" y="1204920"/>
            <a:ext cx="64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CT1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107"/>
          <p:cNvSpPr/>
          <p:nvPr/>
        </p:nvSpPr>
        <p:spPr>
          <a:xfrm>
            <a:off x="4741560" y="1204920"/>
            <a:ext cx="64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CT1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131"/>
          <p:cNvSpPr/>
          <p:nvPr/>
        </p:nvSpPr>
        <p:spPr>
          <a:xfrm>
            <a:off x="446760" y="679320"/>
            <a:ext cx="28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52"/>
          <p:cNvSpPr/>
          <p:nvPr/>
        </p:nvSpPr>
        <p:spPr>
          <a:xfrm>
            <a:off x="4020120" y="67932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직사각형 1"/>
          <p:cNvSpPr/>
          <p:nvPr/>
        </p:nvSpPr>
        <p:spPr>
          <a:xfrm>
            <a:off x="385920" y="3386160"/>
            <a:ext cx="6186240" cy="173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Supplementary Figure S2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  Overexpression of miR-770-5p induces apoptosis via down-regulation of PBK in HCT116 human colon carcinoma cells.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) After transfection of miR-Con or miR-770-5p in HCT116 cells, the relative levels of miR-770-5p and PBK mRNA were confirmed by qRT-PCR.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) Levels of PBK protein and cleaved PARP were observed in miR-Con and miR-770-5p transfected HCT116 cells. Actin was used as a loading control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TextBox 8"/>
          <p:cNvSpPr/>
          <p:nvPr/>
        </p:nvSpPr>
        <p:spPr>
          <a:xfrm>
            <a:off x="52560" y="264960"/>
            <a:ext cx="615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upplementary Table S1. List of 225 mRNAs which were repressed by I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23" name=""/>
          <p:cNvGraphicFramePr/>
          <p:nvPr/>
        </p:nvGraphicFramePr>
        <p:xfrm>
          <a:off x="119160" y="558720"/>
          <a:ext cx="6676920" cy="7326360"/>
        </p:xfrm>
        <a:graphic>
          <a:graphicData uri="http://schemas.openxmlformats.org/drawingml/2006/table">
            <a:tbl>
              <a:tblPr/>
              <a:tblGrid>
                <a:gridCol w="671400"/>
                <a:gridCol w="766800"/>
                <a:gridCol w="922320"/>
                <a:gridCol w="792000"/>
                <a:gridCol w="879480"/>
                <a:gridCol w="782640"/>
                <a:gridCol w="1046160"/>
                <a:gridCol w="816120"/>
              </a:tblGrid>
              <a:tr h="2480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 change (log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 change (log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 change (log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 change (log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B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607199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YN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227880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5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224469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MN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6489092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ES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613935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URK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231279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MB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326712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28388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6801004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PF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694883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CA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236370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PK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572453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BE2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7025896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F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732272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FC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269145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A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6237857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L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8220852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IP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754891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NA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298198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F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792463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orf1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8315273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7orf7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812206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DC28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299947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I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844219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RF1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9358657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FCAB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826174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IF3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30182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853680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ANX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9667367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HRSX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826589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GA2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364677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R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8065471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ANX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9667367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DR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864576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1006309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383868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RP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8399767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RF1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0260668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GO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882261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AT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392684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1002870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8412744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NAH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0498143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LE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906540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KN2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405475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P73-AS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8756805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B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2773206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2orf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944789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MGB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406183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2orf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039027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YCB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3345518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D51AP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947707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RD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443187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LR3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046370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B4B-EGLN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4080290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F1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949805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UBP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521176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IBC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268248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FPL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4892246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TGE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978402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MBX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549946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FDN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297383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NMA6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6085359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997021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C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615152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X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310076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IM39-RPP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7610773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P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009510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SPE1-MOBKL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681122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UN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325452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I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8894396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MC3I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074704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OVE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732543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GO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370165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1005071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9597555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EN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076634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SB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788999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CN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381589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9690412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CNC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089779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YNDIG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789020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F2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390540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B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9830961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80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1005074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091133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MS2L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804222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EB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394927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3399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.988961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PL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121495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10012819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806434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81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450334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HC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4.1192855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CA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162713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B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834949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DUFS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534405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L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4.1520235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ND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2117939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F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866562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111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636470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1005056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4.2479947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K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224364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M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961666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GD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6870859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ED7-TICA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4.2944163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22orf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235473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NIH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018211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BNA1B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690505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A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4.3112888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F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241894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PS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046381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EKHO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835043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A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4.3778412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NMA6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286129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113490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RC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9854980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A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4.6550963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STM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289023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C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149663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F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0062222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A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5.0320782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64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301444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NG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155471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M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0327008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MCX5-GPRAS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5.09322168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PDC1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326033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HRF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164912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NIH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0398748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A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5.5669442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AR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342635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TP11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186835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HEX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0553328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DSS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5.8790871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M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383866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XA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201886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C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0581065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A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6.1342579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AAG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421487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TTL7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245114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198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1008566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C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6.1881147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UK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439315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TP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254463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BXO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1010396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B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6.2488065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FC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448588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IF2B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286887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2F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1015974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C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6.32217846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RG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470795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PS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330721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S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1109069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ACE1-A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6.40483668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ER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535471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BD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337022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DC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1204714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A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6.8953300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PITD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546930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NF1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364780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K3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1283618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Y75-CD3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7.0709150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564262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3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398931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SPB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1361742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B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7.2293218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MYD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582361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F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428567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MA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1496768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DHGB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8.1942515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C25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593599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RTCA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447143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1001292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1933038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BWD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8.7997177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SP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658619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RT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548523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GT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2177446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TCD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4.4465158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25455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681821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BN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613635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S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2358661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816-ZNF321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4.7608491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R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704724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4010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637894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GB3B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2496736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3F3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5.9926594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GT1A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762925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CN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643755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A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2631769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B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6.03975209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SP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8244485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P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687222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T5C1B-RDH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3060515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RGCP-MRPS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7.0095454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RT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833618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KI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722356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O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3201214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IG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8.4608582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RCC6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936910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BXA2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73082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L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3444354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2858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5.8452053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CA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977232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DR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789300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D54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378757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EFF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9.06318198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C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021970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NAH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858475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1001305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4004048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AGE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31.7245016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XNRD3N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035619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F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970557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1005074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4256397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RO7-PAM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72.5390487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ZD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0746918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CA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069072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3GAT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4447288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R5-ARHGAP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84.6481025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NTNA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1588827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XL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132603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BC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4686190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X2-CTNND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61.7651428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MYT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160045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GL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170340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LHL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51140538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CN4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174963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197199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6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5367573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36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A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187141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KA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7205003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3248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PR89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3248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5786714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　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　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TextBox 1"/>
          <p:cNvSpPr/>
          <p:nvPr/>
        </p:nvSpPr>
        <p:spPr>
          <a:xfrm>
            <a:off x="466560" y="263520"/>
            <a:ext cx="5500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Supplementary Table S2. List of 288 putative targets of miR-770-5p predicted based on miRSVR (&lt; -0.75) from </a:t>
            </a:r>
            <a:r>
              <a:rPr b="0" lang="en-US" sz="1200" spc="-1" strike="noStrike" u="sng">
                <a:solidFill>
                  <a:srgbClr val="0000ff"/>
                </a:solidFill>
                <a:uFillTx/>
                <a:latin typeface="Times New Roman"/>
                <a:ea typeface="맑은 고딕"/>
                <a:hlinkClick r:id="rId1"/>
              </a:rPr>
              <a:t>www.microrna.or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websi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25" name=""/>
          <p:cNvGraphicFramePr/>
          <p:nvPr/>
        </p:nvGraphicFramePr>
        <p:xfrm>
          <a:off x="466560" y="731880"/>
          <a:ext cx="5791320" cy="8039160"/>
        </p:xfrm>
        <a:graphic>
          <a:graphicData uri="http://schemas.openxmlformats.org/drawingml/2006/table">
            <a:tbl>
              <a:tblPr/>
              <a:tblGrid>
                <a:gridCol w="785880"/>
                <a:gridCol w="631800"/>
                <a:gridCol w="885960"/>
                <a:gridCol w="606240"/>
                <a:gridCol w="962280"/>
                <a:gridCol w="573120"/>
                <a:gridCol w="900000"/>
                <a:gridCol w="446040"/>
              </a:tblGrid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N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SV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N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SV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N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SV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N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SV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DHHC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2.5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C23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TP4A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MN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A2G4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2orf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BX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LC17A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C3H7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IA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AA01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MT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P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119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CC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CG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136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2orf7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LC12A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BP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KS1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ORT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YO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CCHC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AG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XNDC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CF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NX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GT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IA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L5A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G3L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TPN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PEB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CCHC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G3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orf7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EM2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SS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GI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D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1PR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R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TX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P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ILI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X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PT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MO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GK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PA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NIP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1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X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IAPH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XA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F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2RY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MI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MD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LA-DQB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6412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2orf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GZ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DIA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HOD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OX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CAF12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HGAP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NP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188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IF2C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AT2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TR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KD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FF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R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SD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BX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PL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NF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SP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DCD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AA0664P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FRS13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ACT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F2I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LC4A1A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EM1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L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PHS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TA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TPN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TSC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HAD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P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2D2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D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TERFD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7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NTL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AZ1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O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K38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KIRIN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UZP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PS13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U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BXW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CCI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4orf1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L24A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1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K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XA1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2550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CN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1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NORA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B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KRD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KN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DAM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EM1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S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LG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LOVL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ATS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I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VR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2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DC85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RTAP3-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MC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3GAL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CAM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NE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EP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BS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CF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7orf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CUN1D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P1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D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G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7A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GT2B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EKHA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9orf1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IM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LC25A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MIGO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BLN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KL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MYM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1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LR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XP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M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MARCE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EU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RK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F2I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6orf1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DAM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FI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KA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C1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F2BP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2orf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BNL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G3L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MO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AA10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KD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CIM1D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BM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7A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3RF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TN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CAM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CRG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EM1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P53B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PBP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DC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FG3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orf1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TG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NAJA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C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DGFRP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C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PGEF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3GAL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RC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3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RD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GD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3K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WA3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DR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C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LC30A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XDC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D23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P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SGALNACT1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DC102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EM2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B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4400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NF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Y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PHA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P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BXO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F7I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KA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NAJC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5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DIK1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MD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RNS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CNJ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BQLN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9orf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P1GDS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RX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VE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DC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PG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PN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RANB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IF4G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LC25A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T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SRR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108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CI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MF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CSTD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YST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HD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MP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NT10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TR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DC1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CNJ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LRC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SD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86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V420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2D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ISD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N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M7A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20orf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RC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A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TP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13orf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CNMB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CNG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MD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RFN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XRN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X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KA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MCX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H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IN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LRT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NF6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P1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XPNPEP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HAP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BA4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52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BR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CNK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RSN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IR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368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09T11:14:29Z</dcterms:created>
  <dc:creator>HyungChul Lee</dc:creator>
  <dc:description/>
  <dc:language>en-US</dc:language>
  <cp:lastModifiedBy>vidya.p</cp:lastModifiedBy>
  <dcterms:modified xsi:type="dcterms:W3CDTF">2017-03-16T04:27:53Z</dcterms:modified>
  <cp:revision>1</cp:revision>
  <dc:subject/>
  <dc:title>PowerPoint Presentation</dc:title>
</cp:coreProperties>
</file>